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6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08"/>
      </p:cViewPr>
      <p:guideLst>
        <p:guide orient="horz" pos="2160"/>
        <p:guide pos="6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687F6-4C6B-6369-9EE3-747B93623D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904C71-9921-0489-FE68-2F58FA0D01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5F3E8C-3EA7-0B6E-11CB-78578150F1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34C5A-320A-BA9D-78B6-FFA78DFF8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383971-9224-1610-582B-BB2B51D04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5431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59418-D4DC-BCF2-A1CC-040ECDB70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AD0B398-E485-2DF5-C572-CDEF2930F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57D59-31AD-4200-2C0C-594792137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29A3DC-0E36-FF43-6198-26D49E262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E4A69C-21E0-8CF5-2E64-442D39719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919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AEBBB4B-109F-25E7-C7A1-23051AE2B9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1FEC02-CA38-FA35-3708-AAECE4F5CD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03AE3B-DB34-D978-8009-F0EB6FA10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ABD705-7121-EE04-F395-B70EA1E4E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30317-9FFE-B3AD-6C3D-DDFDECF28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602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8BE75-D11A-A224-8861-1CDC372C9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E04CB8-9C26-6640-5EEE-15381F78C99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3284C-9249-A367-4758-3F919E65D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C0BE36-C7C7-2F19-548E-18227B183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31BE9-E0EB-A0BC-FEE7-F21863842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306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81F13E-7C44-81FB-0AEC-B1B685F451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9E53FE-2ADC-CF38-F440-B50B57B912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14535-4E3C-2531-DA9F-2646B1693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3C9E8-28E2-87D4-DE51-FC8FD67D0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D26FAE-4E8F-6D08-2C19-A541B685A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34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68851-6D8F-0F18-5717-A32E082CFF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1062C8-43E5-D7F5-6B38-D64977278C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84E019-4E04-F969-8C1C-A8260C1E1D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DEB8D5-07EE-963B-D2DF-6672DDF348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C683DE-C2D7-17BC-F470-DD05D38BA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2302EA-1035-F103-84CA-471C3AE76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9428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61BA1-9DBF-BAE2-745D-6098E00453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3DC1B7-A74B-4F72-5BD4-D91956B01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2A0DD8-0C79-011C-26CA-A09176E6B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7EB3F4-A6D3-9682-17FD-A0BB211A9E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F2FFC7-301B-ACC2-E973-5B24523CE8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AFFC61A-0E54-C0A9-C5F1-D1F260AF3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3E1CE56-23B4-F3EB-1781-23F13B990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923681-7EE1-8BC6-C311-AB637D565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43001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E8C014-E56F-1C4F-28A6-90AF332D0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8EC019-E8FA-928D-6E8A-17A5D9775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D10046-BC6F-CBFD-3F93-937392AEA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2DB107-6695-7300-0FDF-E89754411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9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3BFDAF1-9914-E937-8469-4E2F1ED3F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A9CC04-AAC2-B939-5A52-5D2926A74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6231AC-B92E-35B3-0EAF-23C62DAC0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97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02618-FBF5-05D7-D0EA-FA3B7EE80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4E2876-AD8D-136A-79AE-5F18D66FB0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86F49-3275-1039-77E9-1A626663E0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4747B-DA38-16EE-8A25-F1ECFD821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45AC54-B0D0-AF2B-DCB5-BC831A09D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53C102-311D-F2F6-FC04-39D123884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5304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BA4ED-F74E-D1DE-B740-6022A7DB7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49B25D-FA06-7627-2E2B-94D4657312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974699-2556-3095-12CC-C0660D7B92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69598D-A7D9-1364-2E85-E643EA7F3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B34205-E51D-D7B9-19B6-DA3E6C794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630C37-E7EC-7457-3E7F-9ED4E94F8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6946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33A064-A5CF-58A4-0258-5353D75B8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4CD9D3-112C-2181-515B-9932AFE60C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50A63-E4EE-CD8D-73FC-2E9EE9E871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42543F3-53F0-403F-AAF1-95F0222D8B5D}" type="datetimeFigureOut">
              <a:rPr lang="en-GB" smtClean="0"/>
              <a:t>13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0D9E3-209F-D263-FCD0-93420C0BB1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5E218F-96D0-FA11-DFF1-6248769D93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3FE30E-9F50-40F9-9153-7DC38F09472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604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6525ED1-6AAF-77BD-5D5A-D84592CECE5D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53515" y="495301"/>
            <a:ext cx="9284970" cy="5400992"/>
          </a:xfrm>
          <a:prstGeom prst="rect">
            <a:avLst/>
          </a:prstGeom>
          <a:noFill/>
          <a:ln w="9525" cmpd="sng">
            <a:noFill/>
            <a:miter lim="800000"/>
            <a:headEnd/>
            <a:tailEnd/>
          </a:ln>
          <a:effectLst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F70A8C6-3CE4-EABA-204F-CCC9A7F66EF9}"/>
              </a:ext>
            </a:extLst>
          </p:cNvPr>
          <p:cNvSpPr txBox="1"/>
          <p:nvPr/>
        </p:nvSpPr>
        <p:spPr>
          <a:xfrm>
            <a:off x="2105025" y="5781163"/>
            <a:ext cx="7981950" cy="718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upplementary Figure 2. SCFA levels measured at baseline, 8 hours and 24 hours in individual fermentations in the presence of omega-3 PUFAs (1-50 </a:t>
            </a:r>
            <a:r>
              <a:rPr lang="en-GB" sz="1200" b="1" dirty="0">
                <a:effectLst/>
                <a:latin typeface="Symbol" panose="05050102010706020507" pitchFamily="18" charset="2"/>
                <a:ea typeface="Times New Roman" panose="02020603050405020304" pitchFamily="18" charset="0"/>
              </a:rPr>
              <a:t>m</a:t>
            </a:r>
            <a:r>
              <a:rPr lang="en-GB" sz="12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/mL) only.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ncentrations of the individual SCFAs acetate (C2), propionate (C3) and butyrate (C4) are shown, in addition to the total SCFA level, for each participant (P1-P10).</a:t>
            </a:r>
            <a:endParaRPr lang="en-GB" dirty="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AB09E92-CFF0-0EBB-B3C3-53E3C80AD064}"/>
              </a:ext>
            </a:extLst>
          </p:cNvPr>
          <p:cNvGrpSpPr/>
          <p:nvPr/>
        </p:nvGrpSpPr>
        <p:grpSpPr>
          <a:xfrm>
            <a:off x="1856232" y="568683"/>
            <a:ext cx="8677656" cy="230832"/>
            <a:chOff x="1856232" y="568683"/>
            <a:chExt cx="8677656" cy="230832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8C0614DA-BA21-C40B-51FF-92B690E1CCDC}"/>
                </a:ext>
              </a:extLst>
            </p:cNvPr>
            <p:cNvSpPr/>
            <p:nvPr/>
          </p:nvSpPr>
          <p:spPr>
            <a:xfrm>
              <a:off x="1856232" y="589203"/>
              <a:ext cx="8677656" cy="2063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9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9B3B603-7B58-BF5B-F346-48B5A7469C4A}"/>
                </a:ext>
              </a:extLst>
            </p:cNvPr>
            <p:cNvSpPr txBox="1"/>
            <p:nvPr/>
          </p:nvSpPr>
          <p:spPr>
            <a:xfrm>
              <a:off x="2427732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4C6DC90-DB7F-572F-AE05-DD023424E262}"/>
                </a:ext>
              </a:extLst>
            </p:cNvPr>
            <p:cNvSpPr txBox="1"/>
            <p:nvPr/>
          </p:nvSpPr>
          <p:spPr>
            <a:xfrm>
              <a:off x="331631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E0CFAB4-6C20-8C29-C9F9-1F3071352C5E}"/>
                </a:ext>
              </a:extLst>
            </p:cNvPr>
            <p:cNvSpPr txBox="1"/>
            <p:nvPr/>
          </p:nvSpPr>
          <p:spPr>
            <a:xfrm>
              <a:off x="4146614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5F2346D-35DE-761A-F520-512CD2379F41}"/>
                </a:ext>
              </a:extLst>
            </p:cNvPr>
            <p:cNvSpPr txBox="1"/>
            <p:nvPr/>
          </p:nvSpPr>
          <p:spPr>
            <a:xfrm>
              <a:off x="500595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62E5D59-7401-810C-CBA0-37C778DEA394}"/>
                </a:ext>
              </a:extLst>
            </p:cNvPr>
            <p:cNvSpPr txBox="1"/>
            <p:nvPr/>
          </p:nvSpPr>
          <p:spPr>
            <a:xfrm>
              <a:off x="5835015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F575B8C-4806-8E4A-6F96-F20F3B3088DF}"/>
                </a:ext>
              </a:extLst>
            </p:cNvPr>
            <p:cNvSpPr txBox="1"/>
            <p:nvPr/>
          </p:nvSpPr>
          <p:spPr>
            <a:xfrm>
              <a:off x="6699123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B8FA70F-2084-BFE9-1842-12A9CD2EAB24}"/>
                </a:ext>
              </a:extLst>
            </p:cNvPr>
            <p:cNvSpPr txBox="1"/>
            <p:nvPr/>
          </p:nvSpPr>
          <p:spPr>
            <a:xfrm>
              <a:off x="7528179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590DC28-73F1-88EF-E3BF-1E56BB933307}"/>
                </a:ext>
              </a:extLst>
            </p:cNvPr>
            <p:cNvSpPr txBox="1"/>
            <p:nvPr/>
          </p:nvSpPr>
          <p:spPr>
            <a:xfrm>
              <a:off x="8386191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8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A39C09B-2B31-093C-8E65-A4EF921F581E}"/>
                </a:ext>
              </a:extLst>
            </p:cNvPr>
            <p:cNvSpPr txBox="1"/>
            <p:nvPr/>
          </p:nvSpPr>
          <p:spPr>
            <a:xfrm>
              <a:off x="9221343" y="568683"/>
              <a:ext cx="3108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9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4FB4316-E15E-B861-44F5-8723E811FC59}"/>
                </a:ext>
              </a:extLst>
            </p:cNvPr>
            <p:cNvSpPr txBox="1"/>
            <p:nvPr/>
          </p:nvSpPr>
          <p:spPr>
            <a:xfrm>
              <a:off x="10041254" y="568683"/>
              <a:ext cx="3829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>
                  <a:latin typeface="Calibri" panose="020F0502020204030204" pitchFamily="34" charset="0"/>
                  <a:cs typeface="Calibri" panose="020F0502020204030204" pitchFamily="34" charset="0"/>
                </a:rPr>
                <a:t>P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9644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77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Hull</dc:creator>
  <cp:lastModifiedBy>Mark Hull</cp:lastModifiedBy>
  <cp:revision>5</cp:revision>
  <dcterms:created xsi:type="dcterms:W3CDTF">2024-10-08T08:08:35Z</dcterms:created>
  <dcterms:modified xsi:type="dcterms:W3CDTF">2025-01-13T08:26:43Z</dcterms:modified>
</cp:coreProperties>
</file>